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7" r:id="rId2"/>
    <p:sldId id="258" r:id="rId3"/>
    <p:sldId id="265" r:id="rId4"/>
    <p:sldId id="264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4" autoAdjust="0"/>
    <p:restoredTop sz="94660"/>
  </p:normalViewPr>
  <p:slideViewPr>
    <p:cSldViewPr snapToGrid="0">
      <p:cViewPr varScale="1">
        <p:scale>
          <a:sx n="80" d="100"/>
          <a:sy n="80" d="100"/>
        </p:scale>
        <p:origin x="6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D841AE-AE68-4803-8B05-0E56A3298BF3}" type="datetimeFigureOut">
              <a:rPr lang="en-ZA" smtClean="0"/>
              <a:t>2026/02/04</a:t>
            </a:fld>
            <a:endParaRPr lang="en-Z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Z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797869-7983-4A0D-BA26-5DA216C9BE1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168610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77D1304-DFC4-A278-1A1C-6DB4E9FA763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91595A23-AF9A-D754-670F-DAF79F4807BF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4B023C75-D275-C17A-5519-7F02A5B6818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ZA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3C019B8-B327-935F-8D56-94D61D1C41B3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797869-7983-4A0D-BA26-5DA216C9BE1F}" type="slidenum">
              <a:rPr lang="en-ZA" smtClean="0"/>
              <a:t>3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1288839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C3FC0B-3DFE-34DC-E90D-46D24990577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481113F-5217-AB69-42AE-069A67C4D1D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4871A0-6812-528B-F339-A3C9590C26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ED92-BADB-49BD-B684-8BB5EEDCED68}" type="datetimeFigureOut">
              <a:rPr lang="en-ZA" smtClean="0"/>
              <a:t>2026/02/0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9F89BA-E51F-8A9B-7FF1-2B67761FCB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D9AB05-C256-13D7-022A-A12D9369CF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CE48F-72F6-4D71-A124-2C53F0300C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60153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68128D-28F9-477B-E108-888AA1A81C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261CBAF-A831-5124-28C7-FA8295F081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776542-FB89-AD41-D4B7-BD8F694E18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ED92-BADB-49BD-B684-8BB5EEDCED68}" type="datetimeFigureOut">
              <a:rPr lang="en-ZA" smtClean="0"/>
              <a:t>2026/02/0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ED10BB-9949-0980-5E8D-767A84D9F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3127F0-9322-1908-A8C3-92203959E3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CE48F-72F6-4D71-A124-2C53F0300C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44297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FB5DBB4-B92F-1375-9B00-35D0D3A8580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950397E-7E00-3059-0E3B-9075737878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D12F22-F809-723B-421B-170612BC81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ED92-BADB-49BD-B684-8BB5EEDCED68}" type="datetimeFigureOut">
              <a:rPr lang="en-ZA" smtClean="0"/>
              <a:t>2026/02/0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704D35-E01E-7C59-3EC6-E2CFCCDD23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ACBCBE-2E3F-A201-9301-F3DD31A3F3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CE48F-72F6-4D71-A124-2C53F0300C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278993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DF9F9A-E195-51D6-1E78-5333B8D191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25F125-0A49-0F28-72A3-36E859F6AE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887C56-30AE-248B-3592-0C21CD5304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ED92-BADB-49BD-B684-8BB5EEDCED68}" type="datetimeFigureOut">
              <a:rPr lang="en-ZA" smtClean="0"/>
              <a:t>2026/02/0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94703F-8092-D5BF-9B8A-DF12980FF1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4B47DA-EB39-D3E8-7A0E-799C21E5B5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CE48F-72F6-4D71-A124-2C53F0300C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611667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0BE144-D151-9DF6-53AA-396F232C35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737195-1BB0-A70B-469B-6A9515AEE8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DE5C24-3C8E-1EFF-E87C-9E10E16DFF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ED92-BADB-49BD-B684-8BB5EEDCED68}" type="datetimeFigureOut">
              <a:rPr lang="en-ZA" smtClean="0"/>
              <a:t>2026/02/0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B21795-45F6-19C6-C381-4F9D02C254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5C34A2-D24D-012B-0916-3274052BFD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CE48F-72F6-4D71-A124-2C53F0300C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20812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02F54A-B6E5-8AC1-A699-C41903AC52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EA69B4-26ED-87BF-6DE8-47E1D98E88F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32295D-7AF9-26AD-07C7-FC123CBBB2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4A4CA2-DB1D-9A72-09F7-67D412B848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ED92-BADB-49BD-B684-8BB5EEDCED68}" type="datetimeFigureOut">
              <a:rPr lang="en-ZA" smtClean="0"/>
              <a:t>2026/02/04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CE6063-0F03-2265-FC97-E8B1B8FE0A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BD5BDB-75E7-0362-1800-F95035211B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CE48F-72F6-4D71-A124-2C53F0300C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236673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347F11-FD88-FDAB-1932-279C68B727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444EC6-2393-0C5A-E7B5-091DBA20EC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8C252A-A06C-C04E-A1F2-2A6B3C13E1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517A82F-41F6-2524-C2E3-2CB5826141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359B861-3AA2-5222-682D-96E33B1C0C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DD62072-2137-7AB0-628E-9A7F050263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ED92-BADB-49BD-B684-8BB5EEDCED68}" type="datetimeFigureOut">
              <a:rPr lang="en-ZA" smtClean="0"/>
              <a:t>2026/02/04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3E72275-BE5C-B21D-4D69-6B3C449FA1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09DA911-1AA4-BC28-196E-FF6C90F8C4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CE48F-72F6-4D71-A124-2C53F0300C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3959599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F0EBD5-4CD1-6A4B-55A7-36051B5D33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4D675D5-14CF-D545-798D-1B577AC265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ED92-BADB-49BD-B684-8BB5EEDCED68}" type="datetimeFigureOut">
              <a:rPr lang="en-ZA" smtClean="0"/>
              <a:t>2026/02/04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3C49F75-03EE-4404-1E87-8CF94AB784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C8989D9-D714-06C3-A1ED-4E2A69642A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CE48F-72F6-4D71-A124-2C53F0300C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17799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8C12DDB-ACCC-3573-78AF-E813495169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ED92-BADB-49BD-B684-8BB5EEDCED68}" type="datetimeFigureOut">
              <a:rPr lang="en-ZA" smtClean="0"/>
              <a:t>2026/02/04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2F470DA-F7A4-B0A4-1628-BA3659DA61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5B25C5F-72BA-5341-D729-68730AE28C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CE48F-72F6-4D71-A124-2C53F0300C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228514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353E12-946A-A7CD-CD1D-D3D4535219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5D1B51-3893-C4CF-84A1-6855029218A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D949E01-BDE6-F876-F2B2-0B37FACD57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FC57EF-2714-59B0-B39A-4747DFBC66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ED92-BADB-49BD-B684-8BB5EEDCED68}" type="datetimeFigureOut">
              <a:rPr lang="en-ZA" smtClean="0"/>
              <a:t>2026/02/04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C1F031-64AB-E1E1-3011-5E31132FC8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A0727C-89DA-61BC-F613-144ABB3838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CE48F-72F6-4D71-A124-2C53F0300C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49901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8BD344-8FDA-4126-198F-8AD1EC5F5C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C39094F-21C6-B11F-70D8-6DFB1F18272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3214288-4133-AE28-1615-EFEE00BF28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CBD820-9BAA-0FFA-D12E-C30BDA0656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ED92-BADB-49BD-B684-8BB5EEDCED68}" type="datetimeFigureOut">
              <a:rPr lang="en-ZA" smtClean="0"/>
              <a:t>2026/02/04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ABD722-85D8-0EED-BA04-E69E837DF7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1190F80-E265-6FB0-1F3B-76101DDE63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CE48F-72F6-4D71-A124-2C53F0300C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025937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666121B-7774-93A1-BA6E-AF4F4981C7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ED2452-D89A-2DAC-1432-ABC2A1BB76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B7058A-0ED5-0B24-C475-89598B43128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5EBED92-BADB-49BD-B684-8BB5EEDCED68}" type="datetimeFigureOut">
              <a:rPr lang="en-ZA" smtClean="0"/>
              <a:t>2026/02/0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671CDB-8A22-412A-112F-E0F74B706E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D2FA54-1A33-A241-4FB0-8DE04FD8C70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29CE48F-72F6-4D71-A124-2C53F0300C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240498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tif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AD0156E7-70FF-3D30-4382-9F336D2D95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-1" y="-1"/>
            <a:ext cx="18547641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ZA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9258C4E-62B5-0B29-2067-2EA462727724}"/>
              </a:ext>
            </a:extLst>
          </p:cNvPr>
          <p:cNvSpPr txBox="1"/>
          <p:nvPr/>
        </p:nvSpPr>
        <p:spPr>
          <a:xfrm>
            <a:off x="219457" y="5782676"/>
            <a:ext cx="118121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: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rmination of cytotoxic concentrations of PMA in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J-Lat A2 and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J-Lat T66 cells. Cell viability was assessed following treatment with increasing concentrations of PMA for 24 h.</a:t>
            </a:r>
            <a:endParaRPr lang="en-ZA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4935893-EF01-B532-F08E-553CA843CB9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457" y="447333"/>
            <a:ext cx="11655446" cy="48180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84621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3F9F9929-5D53-2C2C-AC20-5894F19D38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-1"/>
            <a:ext cx="20407288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ZA"/>
          </a:p>
        </p:txBody>
      </p:sp>
      <p:sp>
        <p:nvSpPr>
          <p:cNvPr id="6" name="Rectangle 4">
            <a:extLst>
              <a:ext uri="{FF2B5EF4-FFF2-40B4-BE49-F238E27FC236}">
                <a16:creationId xmlns:a16="http://schemas.microsoft.com/office/drawing/2014/main" id="{62BFAF85-B739-CACA-6E03-800841F236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-1"/>
            <a:ext cx="17553932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ZA"/>
          </a:p>
        </p:txBody>
      </p:sp>
      <p:sp>
        <p:nvSpPr>
          <p:cNvPr id="8" name="Rectangle 6">
            <a:extLst>
              <a:ext uri="{FF2B5EF4-FFF2-40B4-BE49-F238E27FC236}">
                <a16:creationId xmlns:a16="http://schemas.microsoft.com/office/drawing/2014/main" id="{5D5790E0-858B-CAD6-8006-3DF8E18BE4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-1" y="-1"/>
            <a:ext cx="18096047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ZA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6EC32BD-A8A1-6DC5-421D-E933C7FB3AD3}"/>
              </a:ext>
            </a:extLst>
          </p:cNvPr>
          <p:cNvSpPr txBox="1"/>
          <p:nvPr/>
        </p:nvSpPr>
        <p:spPr>
          <a:xfrm>
            <a:off x="123431" y="5624097"/>
            <a:ext cx="1184260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: </a:t>
            </a:r>
            <a:r>
              <a:rPr lang="en-Z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activation of latent HIV−1 subtype C (J-Lat T17) cells following treatment with increasing concentrations (1-200 ng/mL) of (</a:t>
            </a:r>
            <a:r>
              <a:rPr lang="en-Z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Z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N and (</a:t>
            </a:r>
            <a:r>
              <a:rPr lang="en-Z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Z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Z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. sericocephala</a:t>
            </a:r>
            <a:r>
              <a:rPr lang="en-Z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 algn="just"/>
            <a:r>
              <a:rPr lang="en-Z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P-positive cell values are expressed as a percentage relative to the untreated control (J-Lat T17) for each replicate. The data show a dose-dependent reactivation of </a:t>
            </a:r>
          </a:p>
          <a:p>
            <a:pPr algn="just"/>
            <a:r>
              <a:rPr lang="en-Z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V−1 latency.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54613CB-CE39-047D-1335-A7E9658A15B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0959" y="277528"/>
            <a:ext cx="10795294" cy="52303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92288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5BA209A-73BA-3D80-88FE-5589A947D60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67FAABB8-D41B-B58A-E1B7-ED8A4C9F826A}"/>
              </a:ext>
            </a:extLst>
          </p:cNvPr>
          <p:cNvSpPr txBox="1"/>
          <p:nvPr/>
        </p:nvSpPr>
        <p:spPr>
          <a:xfrm>
            <a:off x="-23147" y="6239165"/>
            <a:ext cx="121688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: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 for Live/Dead viability assessment in J-Lat cells. Representative flow cytometry gating strategy used to assess cell viability following treatment.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Untreated control and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reated samples are shown. Lymphocytes were first identified based on FSC-A/SSC-A, followed by doublet exclusion using FSC-A/FSC-H and SSC-A/SSC-H. Live cells were defined by exclusion of DAPI-positive events. This assay was used exclusively to quantify cell viability and was not intended to assess HIV-1 reactivation.</a:t>
            </a:r>
            <a:endParaRPr lang="en-Z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F5575E7-D24F-5802-81A9-BD9414386B87}"/>
              </a:ext>
            </a:extLst>
          </p:cNvPr>
          <p:cNvSpPr txBox="1"/>
          <p:nvPr/>
        </p:nvSpPr>
        <p:spPr>
          <a:xfrm>
            <a:off x="-3" y="-39339"/>
            <a:ext cx="6126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ZA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660835A-8404-17BD-8D91-96C44E4B9381}"/>
              </a:ext>
            </a:extLst>
          </p:cNvPr>
          <p:cNvSpPr txBox="1"/>
          <p:nvPr/>
        </p:nvSpPr>
        <p:spPr>
          <a:xfrm>
            <a:off x="-3" y="2975858"/>
            <a:ext cx="595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ZA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E4FDE5C-AA30-50B8-0AD7-3BE7EB30E4B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4" t="3689" r="380" b="24352"/>
          <a:stretch>
            <a:fillRect/>
          </a:stretch>
        </p:blipFill>
        <p:spPr>
          <a:xfrm>
            <a:off x="-23147" y="318855"/>
            <a:ext cx="12041534" cy="288209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B115FF0-8C3E-E0A9-3283-1380C41C5F9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4" t="2009" r="380" b="24419"/>
          <a:stretch>
            <a:fillRect/>
          </a:stretch>
        </p:blipFill>
        <p:spPr>
          <a:xfrm>
            <a:off x="127322" y="3286814"/>
            <a:ext cx="11902641" cy="29861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004843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76DBCD32-9A35-530A-D7B5-38473CFED1E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07524662"/>
              </p:ext>
            </p:extLst>
          </p:nvPr>
        </p:nvGraphicFramePr>
        <p:xfrm>
          <a:off x="595131" y="1169019"/>
          <a:ext cx="11268919" cy="5011866"/>
        </p:xfrm>
        <a:graphic>
          <a:graphicData uri="http://schemas.openxmlformats.org/drawingml/2006/table">
            <a:tbl>
              <a:tblPr/>
              <a:tblGrid>
                <a:gridCol w="890423">
                  <a:extLst>
                    <a:ext uri="{9D8B030D-6E8A-4147-A177-3AD203B41FA5}">
                      <a16:colId xmlns:a16="http://schemas.microsoft.com/office/drawing/2014/main" val="3687973297"/>
                    </a:ext>
                  </a:extLst>
                </a:gridCol>
                <a:gridCol w="834977">
                  <a:extLst>
                    <a:ext uri="{9D8B030D-6E8A-4147-A177-3AD203B41FA5}">
                      <a16:colId xmlns:a16="http://schemas.microsoft.com/office/drawing/2014/main" val="447843809"/>
                    </a:ext>
                  </a:extLst>
                </a:gridCol>
                <a:gridCol w="2025471">
                  <a:extLst>
                    <a:ext uri="{9D8B030D-6E8A-4147-A177-3AD203B41FA5}">
                      <a16:colId xmlns:a16="http://schemas.microsoft.com/office/drawing/2014/main" val="1866302482"/>
                    </a:ext>
                  </a:extLst>
                </a:gridCol>
                <a:gridCol w="1594935">
                  <a:extLst>
                    <a:ext uri="{9D8B030D-6E8A-4147-A177-3AD203B41FA5}">
                      <a16:colId xmlns:a16="http://schemas.microsoft.com/office/drawing/2014/main" val="584335131"/>
                    </a:ext>
                  </a:extLst>
                </a:gridCol>
                <a:gridCol w="1852603">
                  <a:extLst>
                    <a:ext uri="{9D8B030D-6E8A-4147-A177-3AD203B41FA5}">
                      <a16:colId xmlns:a16="http://schemas.microsoft.com/office/drawing/2014/main" val="2437840096"/>
                    </a:ext>
                  </a:extLst>
                </a:gridCol>
                <a:gridCol w="1343790">
                  <a:extLst>
                    <a:ext uri="{9D8B030D-6E8A-4147-A177-3AD203B41FA5}">
                      <a16:colId xmlns:a16="http://schemas.microsoft.com/office/drawing/2014/main" val="1457985380"/>
                    </a:ext>
                  </a:extLst>
                </a:gridCol>
                <a:gridCol w="939348">
                  <a:extLst>
                    <a:ext uri="{9D8B030D-6E8A-4147-A177-3AD203B41FA5}">
                      <a16:colId xmlns:a16="http://schemas.microsoft.com/office/drawing/2014/main" val="4111323612"/>
                    </a:ext>
                  </a:extLst>
                </a:gridCol>
                <a:gridCol w="1082860">
                  <a:extLst>
                    <a:ext uri="{9D8B030D-6E8A-4147-A177-3AD203B41FA5}">
                      <a16:colId xmlns:a16="http://schemas.microsoft.com/office/drawing/2014/main" val="431111900"/>
                    </a:ext>
                  </a:extLst>
                </a:gridCol>
                <a:gridCol w="704512">
                  <a:extLst>
                    <a:ext uri="{9D8B030D-6E8A-4147-A177-3AD203B41FA5}">
                      <a16:colId xmlns:a16="http://schemas.microsoft.com/office/drawing/2014/main" val="1503877095"/>
                    </a:ext>
                  </a:extLst>
                </a:gridCol>
              </a:tblGrid>
              <a:tr h="228802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ZA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-Lat T66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2711611"/>
                  </a:ext>
                </a:extLst>
              </a:tr>
              <a:tr h="44671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ZA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nobinostat + </a:t>
                      </a:r>
                      <a:r>
                        <a:rPr lang="en-ZA" sz="12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. sericocephala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ZA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HA + </a:t>
                      </a:r>
                      <a:r>
                        <a:rPr lang="en-ZA" sz="12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. sericocephala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-alpha + </a:t>
                      </a:r>
                      <a:r>
                        <a:rPr lang="en-ZA" sz="12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. sericocephala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nobinostat + PN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HA + PN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-alpha + PN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ank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3710406"/>
                  </a:ext>
                </a:extLst>
              </a:tr>
              <a:tr h="228802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192678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76557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40262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151868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8781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353785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73297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501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9987122"/>
                  </a:ext>
                </a:extLst>
              </a:tr>
              <a:tr h="228802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374853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87665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995136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240495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4328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591530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459696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577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7160990"/>
                  </a:ext>
                </a:extLst>
              </a:tr>
              <a:tr h="228802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93755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85531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15822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293416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2899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445033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481369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270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6454954"/>
                  </a:ext>
                </a:extLst>
              </a:tr>
              <a:tr h="228802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87095,3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49917,667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83740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228593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5336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130116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571454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449,33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0151840"/>
                  </a:ext>
                </a:extLst>
              </a:tr>
              <a:tr h="228802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us blank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54646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17468,333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51290,667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196143,67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2886,6667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097666,67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539004,67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2051656"/>
                  </a:ext>
                </a:extLst>
              </a:tr>
              <a:tr h="228802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ddev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23933,45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7575,8438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02136,802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520,64233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940,15896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6300,7533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44849,825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2152682"/>
                  </a:ext>
                </a:extLst>
              </a:tr>
              <a:tr h="228802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viability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,83596375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,69855877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3,363168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737864002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1,7205892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,00093235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31415273"/>
                  </a:ext>
                </a:extLst>
              </a:tr>
              <a:tr h="228802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25776977"/>
                  </a:ext>
                </a:extLst>
              </a:tr>
              <a:tr h="228802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ZA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-Lat A2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8876916"/>
                  </a:ext>
                </a:extLst>
              </a:tr>
              <a:tr h="44671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nobinostat + </a:t>
                      </a:r>
                      <a:r>
                        <a:rPr lang="en-ZA" sz="12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. sericocephala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ZA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HA + </a:t>
                      </a:r>
                      <a:r>
                        <a:rPr lang="en-ZA" sz="12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. sericocephala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-alpha + </a:t>
                      </a:r>
                      <a:r>
                        <a:rPr lang="en-ZA" sz="12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. sericocephala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nobinostat + PN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HA + PN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-alpha + PN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8437483"/>
                  </a:ext>
                </a:extLst>
              </a:tr>
              <a:tr h="228802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192678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99988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780634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326322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81758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209578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911644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6368173"/>
                  </a:ext>
                </a:extLst>
              </a:tr>
              <a:tr h="228802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374853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48707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809832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763217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87731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873340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780904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62009"/>
                  </a:ext>
                </a:extLst>
              </a:tr>
              <a:tr h="228802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93755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39805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186000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18028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82474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129672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585680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222856"/>
                  </a:ext>
                </a:extLst>
              </a:tr>
              <a:tr h="228802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87095,3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29500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925488,67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635855,67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83987,667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737530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426076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81413860"/>
                  </a:ext>
                </a:extLst>
              </a:tr>
              <a:tr h="228802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us blank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54646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97050,667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893039,33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603406,33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51538,333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705080,67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393626,67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97387700"/>
                  </a:ext>
                </a:extLst>
              </a:tr>
              <a:tr h="228802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ddev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23933,45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4423,2779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94688,556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89368,547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3871,4414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2614,25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6079,2853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5034581"/>
                  </a:ext>
                </a:extLst>
              </a:tr>
              <a:tr h="228802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viability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,2172651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6,1753059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7,1386298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,51663602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4,4328659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ZA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2,2752464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670404"/>
                  </a:ext>
                </a:extLst>
              </a:tr>
              <a:tr h="228802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139" marR="9139" marT="913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1472008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E6E3D5E4-7334-AB05-0965-F88F36877044}"/>
              </a:ext>
            </a:extLst>
          </p:cNvPr>
          <p:cNvSpPr txBox="1"/>
          <p:nvPr/>
        </p:nvSpPr>
        <p:spPr>
          <a:xfrm>
            <a:off x="752354" y="833377"/>
            <a:ext cx="84484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1: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Titer-Glo data showing absolute viability of J-Lat cells following PN and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. sericocephal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ment.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ZA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33443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7F8177AC-6C39-6191-A652-8EF4F75B75E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4974260"/>
              </p:ext>
            </p:extLst>
          </p:nvPr>
        </p:nvGraphicFramePr>
        <p:xfrm>
          <a:off x="1307939" y="1293471"/>
          <a:ext cx="9282896" cy="4271058"/>
        </p:xfrm>
        <a:graphic>
          <a:graphicData uri="http://schemas.openxmlformats.org/drawingml/2006/table">
            <a:tbl>
              <a:tblPr firstRow="1" firstCol="1" bandRow="1"/>
              <a:tblGrid>
                <a:gridCol w="2153656">
                  <a:extLst>
                    <a:ext uri="{9D8B030D-6E8A-4147-A177-3AD203B41FA5}">
                      <a16:colId xmlns:a16="http://schemas.microsoft.com/office/drawing/2014/main" val="1869696389"/>
                    </a:ext>
                  </a:extLst>
                </a:gridCol>
                <a:gridCol w="1570802">
                  <a:extLst>
                    <a:ext uri="{9D8B030D-6E8A-4147-A177-3AD203B41FA5}">
                      <a16:colId xmlns:a16="http://schemas.microsoft.com/office/drawing/2014/main" val="2891668082"/>
                    </a:ext>
                  </a:extLst>
                </a:gridCol>
                <a:gridCol w="1570802">
                  <a:extLst>
                    <a:ext uri="{9D8B030D-6E8A-4147-A177-3AD203B41FA5}">
                      <a16:colId xmlns:a16="http://schemas.microsoft.com/office/drawing/2014/main" val="1150988956"/>
                    </a:ext>
                  </a:extLst>
                </a:gridCol>
                <a:gridCol w="1993818">
                  <a:extLst>
                    <a:ext uri="{9D8B030D-6E8A-4147-A177-3AD203B41FA5}">
                      <a16:colId xmlns:a16="http://schemas.microsoft.com/office/drawing/2014/main" val="1946084035"/>
                    </a:ext>
                  </a:extLst>
                </a:gridCol>
                <a:gridCol w="1993818">
                  <a:extLst>
                    <a:ext uri="{9D8B030D-6E8A-4147-A177-3AD203B41FA5}">
                      <a16:colId xmlns:a16="http://schemas.microsoft.com/office/drawing/2014/main" val="698844905"/>
                    </a:ext>
                  </a:extLst>
                </a:gridCol>
              </a:tblGrid>
              <a:tr h="655281">
                <a:tc rowSpan="3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8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Latency reversal agents (LRAs) and extracts</a:t>
                      </a:r>
                      <a:endParaRPr lang="en-ZA" sz="18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8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                            FICI</a:t>
                      </a:r>
                      <a:endParaRPr lang="en-ZA" sz="18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4739884"/>
                  </a:ext>
                </a:extLst>
              </a:tr>
              <a:tr h="887697">
                <a:tc v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800" b="1" kern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oduct Nkabinde</a:t>
                      </a:r>
                      <a:endParaRPr lang="en-ZA" sz="18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800" b="1" i="1" kern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nidia sericocephala</a:t>
                      </a:r>
                      <a:endParaRPr lang="en-ZA" sz="18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81108847"/>
                  </a:ext>
                </a:extLst>
              </a:tr>
              <a:tr h="708759">
                <a:tc v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8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J-Lat A2</a:t>
                      </a:r>
                      <a:endParaRPr lang="en-ZA" sz="18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8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J-Lat T66</a:t>
                      </a:r>
                      <a:endParaRPr lang="en-ZA" sz="18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8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J-Lat A2</a:t>
                      </a:r>
                      <a:endParaRPr lang="en-ZA" sz="18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8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J-Lat T66</a:t>
                      </a:r>
                      <a:endParaRPr lang="en-ZA" sz="18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3366080"/>
                  </a:ext>
                </a:extLst>
              </a:tr>
              <a:tr h="70875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8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Panobinostat</a:t>
                      </a:r>
                      <a:endParaRPr lang="en-ZA" sz="18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800" kern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6</a:t>
                      </a:r>
                      <a:endParaRPr lang="en-ZA" sz="18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800" kern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.61</a:t>
                      </a:r>
                      <a:endParaRPr lang="en-ZA" sz="18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800" kern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.24</a:t>
                      </a:r>
                      <a:endParaRPr lang="en-ZA" sz="18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800" kern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4.01</a:t>
                      </a:r>
                      <a:endParaRPr lang="en-ZA" sz="18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4348982"/>
                  </a:ext>
                </a:extLst>
              </a:tr>
              <a:tr h="65528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8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SAHA</a:t>
                      </a:r>
                      <a:endParaRPr lang="en-ZA" sz="18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800" kern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5</a:t>
                      </a:r>
                      <a:endParaRPr lang="en-ZA" sz="18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800" kern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3.2</a:t>
                      </a:r>
                      <a:endParaRPr lang="en-ZA" sz="18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800" kern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3.79</a:t>
                      </a:r>
                      <a:endParaRPr lang="en-ZA" sz="18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800" kern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7.2</a:t>
                      </a:r>
                      <a:endParaRPr lang="en-ZA" sz="18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2354376"/>
                  </a:ext>
                </a:extLst>
              </a:tr>
              <a:tr h="65528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8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TNF-</a:t>
                      </a:r>
                      <a:r>
                        <a:rPr lang="el-GR" sz="18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α</a:t>
                      </a:r>
                      <a:endParaRPr lang="en-ZA" sz="18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8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9.93</a:t>
                      </a:r>
                      <a:endParaRPr lang="en-ZA" sz="18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8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41.35</a:t>
                      </a:r>
                      <a:endParaRPr lang="en-ZA" sz="18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800" kern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9</a:t>
                      </a:r>
                      <a:endParaRPr lang="en-ZA" sz="18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ZA" sz="1800" kern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9.7</a:t>
                      </a:r>
                      <a:endParaRPr lang="en-ZA" sz="18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43531516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B7D67D8E-6DE7-162C-1E1C-5B08F350FCA0}"/>
              </a:ext>
            </a:extLst>
          </p:cNvPr>
          <p:cNvSpPr txBox="1"/>
          <p:nvPr/>
        </p:nvSpPr>
        <p:spPr>
          <a:xfrm>
            <a:off x="1164702" y="1000762"/>
            <a:ext cx="9569369" cy="2927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  <a:buNone/>
            </a:pPr>
            <a:r>
              <a:rPr lang="en-GB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Table S2: </a:t>
            </a:r>
            <a:r>
              <a:rPr lang="en-ZA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ractional inhibitory concentration index (FICI) calculations for PN and </a:t>
            </a:r>
            <a:r>
              <a:rPr lang="en-ZA" sz="12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G. sericocephala</a:t>
            </a:r>
            <a:r>
              <a:rPr lang="en-ZA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versus latency-reversing agents.</a:t>
            </a:r>
            <a:endParaRPr lang="en-ZA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30824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00</TotalTime>
  <Words>516</Words>
  <Application>Microsoft Office PowerPoint</Application>
  <PresentationFormat>Widescreen</PresentationFormat>
  <Paragraphs>213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hanyisile Mngomezulu (210514678)</dc:creator>
  <cp:lastModifiedBy>Khanyisile Mngomezulu (210514678)</cp:lastModifiedBy>
  <cp:revision>7</cp:revision>
  <dcterms:created xsi:type="dcterms:W3CDTF">2025-10-25T11:20:43Z</dcterms:created>
  <dcterms:modified xsi:type="dcterms:W3CDTF">2026-02-05T05:16:18Z</dcterms:modified>
</cp:coreProperties>
</file>